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118872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1" d="100"/>
          <a:sy n="61" d="100"/>
        </p:scale>
        <p:origin x="118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357625876462295E-2"/>
          <c:y val="0.17171296296296301"/>
          <c:w val="0.89075572837597705"/>
          <c:h val="0.61498432487605703"/>
        </c:manualLayout>
      </c:layout>
      <c:lineChart>
        <c:grouping val="standard"/>
        <c:varyColors val="0"/>
        <c:ser>
          <c:idx val="0"/>
          <c:order val="0"/>
          <c:tx>
            <c:strRef>
              <c:f>Sheet1!$B$31</c:f>
              <c:strCache>
                <c:ptCount val="1"/>
                <c:pt idx="0">
                  <c:v>Prostratin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C$30:$J$30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8</c:v>
                </c:pt>
              </c:numCache>
            </c:numRef>
          </c:cat>
          <c:val>
            <c:numRef>
              <c:f>Sheet1!$C$31:$J$31</c:f>
              <c:numCache>
                <c:formatCode>General</c:formatCode>
                <c:ptCount val="8"/>
                <c:pt idx="0">
                  <c:v>1</c:v>
                </c:pt>
                <c:pt idx="1">
                  <c:v>3.7559480000000001</c:v>
                </c:pt>
                <c:pt idx="2">
                  <c:v>6.2792469999999998</c:v>
                </c:pt>
                <c:pt idx="3">
                  <c:v>8.890663</c:v>
                </c:pt>
                <c:pt idx="4">
                  <c:v>10.10572</c:v>
                </c:pt>
                <c:pt idx="5">
                  <c:v>11.51357</c:v>
                </c:pt>
                <c:pt idx="6">
                  <c:v>12.23194</c:v>
                </c:pt>
                <c:pt idx="7">
                  <c:v>12.62933999999999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B$32</c:f>
              <c:strCache>
                <c:ptCount val="1"/>
                <c:pt idx="0">
                  <c:v>SAHA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C$30:$J$30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8</c:v>
                </c:pt>
              </c:numCache>
            </c:numRef>
          </c:cat>
          <c:val>
            <c:numRef>
              <c:f>Sheet1!$C$32:$J$32</c:f>
              <c:numCache>
                <c:formatCode>General</c:formatCode>
                <c:ptCount val="8"/>
                <c:pt idx="0">
                  <c:v>1</c:v>
                </c:pt>
                <c:pt idx="1">
                  <c:v>1.4266829999999999</c:v>
                </c:pt>
                <c:pt idx="2">
                  <c:v>3.7906879999999998</c:v>
                </c:pt>
                <c:pt idx="3">
                  <c:v>7.6914610000000003</c:v>
                </c:pt>
                <c:pt idx="4">
                  <c:v>11.75409</c:v>
                </c:pt>
                <c:pt idx="5">
                  <c:v>14.590529999999999</c:v>
                </c:pt>
                <c:pt idx="6">
                  <c:v>16.427050000000001</c:v>
                </c:pt>
                <c:pt idx="7">
                  <c:v>18.4550300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B$33</c:f>
              <c:strCache>
                <c:ptCount val="1"/>
                <c:pt idx="0">
                  <c:v>TNF</c:v>
                </c:pt>
              </c:strCache>
            </c:strRef>
          </c:tx>
          <c:spPr>
            <a:ln w="254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triangle"/>
            <c:size val="8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C$30:$J$30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8</c:v>
                </c:pt>
              </c:numCache>
            </c:numRef>
          </c:cat>
          <c:val>
            <c:numRef>
              <c:f>Sheet1!$C$33:$J$33</c:f>
              <c:numCache>
                <c:formatCode>General</c:formatCode>
                <c:ptCount val="8"/>
                <c:pt idx="0">
                  <c:v>1</c:v>
                </c:pt>
                <c:pt idx="1">
                  <c:v>4.3296580000000002</c:v>
                </c:pt>
                <c:pt idx="2">
                  <c:v>5.6126690000000004</c:v>
                </c:pt>
                <c:pt idx="3">
                  <c:v>5.378158</c:v>
                </c:pt>
                <c:pt idx="4">
                  <c:v>6.0479769999999986</c:v>
                </c:pt>
                <c:pt idx="5">
                  <c:v>7.6380980000000003</c:v>
                </c:pt>
                <c:pt idx="6">
                  <c:v>7.1320189999999988</c:v>
                </c:pt>
                <c:pt idx="7">
                  <c:v>7.37640299999999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6796600"/>
        <c:axId val="131564688"/>
      </c:lineChart>
      <c:dateAx>
        <c:axId val="166796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564688"/>
        <c:crosses val="autoZero"/>
        <c:auto val="0"/>
        <c:lblOffset val="100"/>
        <c:baseTimeUnit val="days"/>
      </c:dateAx>
      <c:valAx>
        <c:axId val="1315646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6796600"/>
        <c:crosses val="autoZero"/>
        <c:crossBetween val="between"/>
        <c:majorUnit val="5"/>
      </c:valAx>
      <c:spPr>
        <a:noFill/>
        <a:ln w="254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10234112051684"/>
          <c:y val="0.199652230971129"/>
          <c:w val="0.24780768946520801"/>
          <c:h val="0.236541486293200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45429"/>
            <a:ext cx="7772400" cy="41385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243533"/>
            <a:ext cx="6858000" cy="286998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350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948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32883"/>
            <a:ext cx="1971675" cy="1007385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32883"/>
            <a:ext cx="5800725" cy="1007385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966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117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963549"/>
            <a:ext cx="7886700" cy="494474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7955072"/>
            <a:ext cx="7886700" cy="260032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49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164417"/>
            <a:ext cx="3886200" cy="754231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164417"/>
            <a:ext cx="3886200" cy="754231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856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32886"/>
            <a:ext cx="7886700" cy="229764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14016"/>
            <a:ext cx="3868340" cy="14281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342130"/>
            <a:ext cx="3868340" cy="638661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14016"/>
            <a:ext cx="3887391" cy="14281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342130"/>
            <a:ext cx="3887391" cy="638661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85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129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962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92480"/>
            <a:ext cx="2949178" cy="27736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11539"/>
            <a:ext cx="4629150" cy="844761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566160"/>
            <a:ext cx="2949178" cy="66067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456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92480"/>
            <a:ext cx="2949178" cy="27736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11539"/>
            <a:ext cx="4629150" cy="844761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566160"/>
            <a:ext cx="2949178" cy="66067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96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32886"/>
            <a:ext cx="7886700" cy="22976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164417"/>
            <a:ext cx="7886700" cy="75423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017676"/>
            <a:ext cx="20574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BA56F-531B-4D64-8613-F87A475BDC6B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017676"/>
            <a:ext cx="30861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017676"/>
            <a:ext cx="20574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DD48C-6F33-4020-A0FF-8B6F5C2A6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330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458867" y="878091"/>
            <a:ext cx="6469860" cy="1173550"/>
            <a:chOff x="1531056" y="2686551"/>
            <a:chExt cx="6469860" cy="1173550"/>
          </a:xfrm>
        </p:grpSpPr>
        <p:cxnSp>
          <p:nvCxnSpPr>
            <p:cNvPr id="5" name="Straight Connector 4"/>
            <p:cNvCxnSpPr/>
            <p:nvPr/>
          </p:nvCxnSpPr>
          <p:spPr>
            <a:xfrm flipV="1">
              <a:off x="2076450" y="3128207"/>
              <a:ext cx="523875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2076450" y="3031955"/>
              <a:ext cx="0" cy="20453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7315200" y="3025938"/>
              <a:ext cx="0" cy="20453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1531056" y="2727215"/>
              <a:ext cx="10951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916815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767614" y="2686551"/>
              <a:ext cx="10951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606068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ight Arrow 9"/>
            <p:cNvSpPr/>
            <p:nvPr/>
          </p:nvSpPr>
          <p:spPr>
            <a:xfrm flipH="1">
              <a:off x="2822420" y="3371850"/>
              <a:ext cx="475592" cy="180474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ight Arrow 10"/>
            <p:cNvSpPr/>
            <p:nvPr/>
          </p:nvSpPr>
          <p:spPr>
            <a:xfrm flipH="1">
              <a:off x="2160003" y="3371850"/>
              <a:ext cx="274320" cy="180474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ight Arrow 11"/>
            <p:cNvSpPr/>
            <p:nvPr/>
          </p:nvSpPr>
          <p:spPr>
            <a:xfrm>
              <a:off x="3686109" y="3369444"/>
              <a:ext cx="3544870" cy="182880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ight Arrow 12"/>
            <p:cNvSpPr/>
            <p:nvPr/>
          </p:nvSpPr>
          <p:spPr>
            <a:xfrm flipH="1">
              <a:off x="3525763" y="3605719"/>
              <a:ext cx="137160" cy="180474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ight Arrow 13"/>
            <p:cNvSpPr/>
            <p:nvPr/>
          </p:nvSpPr>
          <p:spPr>
            <a:xfrm>
              <a:off x="2454821" y="3605719"/>
              <a:ext cx="365760" cy="184887"/>
            </a:xfrm>
            <a:prstGeom prst="rightArrow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662971" y="3120637"/>
              <a:ext cx="881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5C3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198822" y="3306995"/>
              <a:ext cx="6639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BS9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643897" y="3542067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9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734808" y="3552324"/>
              <a:ext cx="7729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KBP9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572371" y="3304898"/>
              <a:ext cx="6543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9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Isosceles Triangle 19"/>
            <p:cNvSpPr/>
            <p:nvPr/>
          </p:nvSpPr>
          <p:spPr>
            <a:xfrm rot="5400000" flipH="1">
              <a:off x="2544774" y="2783531"/>
              <a:ext cx="228600" cy="2286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Isosceles Triangle 20"/>
            <p:cNvSpPr/>
            <p:nvPr/>
          </p:nvSpPr>
          <p:spPr>
            <a:xfrm rot="5400000" flipH="1">
              <a:off x="7772316" y="2730667"/>
              <a:ext cx="228600" cy="2286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1662619" y="2281726"/>
            <a:ext cx="5710320" cy="3639344"/>
            <a:chOff x="1497724" y="805656"/>
            <a:chExt cx="5710320" cy="3639344"/>
          </a:xfrm>
        </p:grpSpPr>
        <p:grpSp>
          <p:nvGrpSpPr>
            <p:cNvPr id="23" name="Group 22"/>
            <p:cNvGrpSpPr/>
            <p:nvPr/>
          </p:nvGrpSpPr>
          <p:grpSpPr>
            <a:xfrm>
              <a:off x="2012156" y="805656"/>
              <a:ext cx="5195888" cy="3639344"/>
              <a:chOff x="1974056" y="1745456"/>
              <a:chExt cx="5195888" cy="3639344"/>
            </a:xfrm>
          </p:grpSpPr>
          <p:graphicFrame>
            <p:nvGraphicFramePr>
              <p:cNvPr id="26" name="Chart 2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88857710"/>
                  </p:ext>
                </p:extLst>
              </p:nvPr>
            </p:nvGraphicFramePr>
            <p:xfrm>
              <a:off x="1974056" y="1745456"/>
              <a:ext cx="5195888" cy="363934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7" name="TextBox 26"/>
              <p:cNvSpPr txBox="1"/>
              <p:nvPr/>
            </p:nvSpPr>
            <p:spPr>
              <a:xfrm>
                <a:off x="2374900" y="4635500"/>
                <a:ext cx="47564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       2        4        6        8      10       12                         18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TextBox 23"/>
            <p:cNvSpPr txBox="1"/>
            <p:nvPr/>
          </p:nvSpPr>
          <p:spPr>
            <a:xfrm>
              <a:off x="3902107" y="4008316"/>
              <a:ext cx="13147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hours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6200000" flipH="1">
              <a:off x="871431" y="2201602"/>
              <a:ext cx="183736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5C3 transcript</a:t>
              </a:r>
            </a:p>
            <a:p>
              <a:pPr algn="ctr"/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old </a:t>
              </a:r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ange)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155332" y="670045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5332" y="2589713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11839" y="3544285"/>
            <a:ext cx="3577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400" b="1" dirty="0" smtClean="0">
                <a:latin typeface="Symbol" panose="05050102010706020507" pitchFamily="18" charset="2"/>
              </a:rPr>
              <a:t>a</a:t>
            </a:r>
            <a:endParaRPr lang="en-US" sz="1400" b="1" dirty="0">
              <a:latin typeface="Symbol" panose="05050102010706020507" pitchFamily="18" charset="2"/>
            </a:endParaRPr>
          </a:p>
        </p:txBody>
      </p:sp>
      <p:grpSp>
        <p:nvGrpSpPr>
          <p:cNvPr id="53" name="Group 52"/>
          <p:cNvGrpSpPr/>
          <p:nvPr/>
        </p:nvGrpSpPr>
        <p:grpSpPr>
          <a:xfrm>
            <a:off x="2633122" y="6528028"/>
            <a:ext cx="4562067" cy="3753252"/>
            <a:chOff x="2144390" y="6086583"/>
            <a:chExt cx="4562067" cy="3753252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39" t="16678" r="8094" b="40601"/>
            <a:stretch/>
          </p:blipFill>
          <p:spPr>
            <a:xfrm>
              <a:off x="2144391" y="7684462"/>
              <a:ext cx="3363685" cy="112667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02" t="34730" r="17131" b="20309"/>
            <a:stretch/>
          </p:blipFill>
          <p:spPr>
            <a:xfrm>
              <a:off x="2144390" y="9105049"/>
              <a:ext cx="3363686" cy="73478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34" name="TextBox 33"/>
            <p:cNvSpPr txBox="1"/>
            <p:nvPr/>
          </p:nvSpPr>
          <p:spPr>
            <a:xfrm rot="16200000">
              <a:off x="2322624" y="7126762"/>
              <a:ext cx="691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2461360" y="6964184"/>
              <a:ext cx="11416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ostr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8hr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2818075" y="6914491"/>
              <a:ext cx="11157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HA 18hr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3239455" y="6992109"/>
              <a:ext cx="9605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 18hr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3788698" y="7126761"/>
              <a:ext cx="691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3864552" y="6964183"/>
              <a:ext cx="11416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ostr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8hr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4232637" y="6914490"/>
              <a:ext cx="11157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HA 18hr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4641139" y="6992108"/>
              <a:ext cx="9605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 18hr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776908" y="7948686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5C3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776907" y="8247797"/>
              <a:ext cx="861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5C3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776907" y="9306521"/>
              <a:ext cx="9295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Straight Arrow Connector 44"/>
            <p:cNvCxnSpPr/>
            <p:nvPr/>
          </p:nvCxnSpPr>
          <p:spPr>
            <a:xfrm flipH="1">
              <a:off x="5556204" y="8102574"/>
              <a:ext cx="182880" cy="0"/>
            </a:xfrm>
            <a:prstGeom prst="straightConnector1">
              <a:avLst/>
            </a:prstGeom>
            <a:ln w="50800">
              <a:solidFill>
                <a:schemeClr val="tx1"/>
              </a:solidFill>
              <a:headEnd w="sm" len="lg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2793545" y="6086583"/>
              <a:ext cx="8228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ACH2 </a:t>
              </a:r>
              <a:endParaRPr lang="en-US" sz="2000" b="1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267105" y="6086583"/>
              <a:ext cx="85632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A3.01 </a:t>
              </a:r>
              <a:endParaRPr lang="en-US" sz="2000" b="1" dirty="0"/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2514343" y="6505353"/>
              <a:ext cx="135926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4020513" y="6505353"/>
              <a:ext cx="135926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 flipH="1">
              <a:off x="5568236" y="8359057"/>
              <a:ext cx="182880" cy="0"/>
            </a:xfrm>
            <a:prstGeom prst="straightConnector1">
              <a:avLst/>
            </a:prstGeom>
            <a:ln w="50800">
              <a:solidFill>
                <a:schemeClr val="tx1"/>
              </a:solidFill>
              <a:headEnd w="sm" len="lg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 flipH="1">
              <a:off x="5556204" y="9472441"/>
              <a:ext cx="182880" cy="0"/>
            </a:xfrm>
            <a:prstGeom prst="straightConnector1">
              <a:avLst/>
            </a:prstGeom>
            <a:ln w="50800">
              <a:solidFill>
                <a:schemeClr val="tx1"/>
              </a:solidFill>
              <a:headEnd w="sm" len="lg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2" name="TextBox 51"/>
          <p:cNvSpPr txBox="1"/>
          <p:nvPr/>
        </p:nvSpPr>
        <p:spPr>
          <a:xfrm>
            <a:off x="160251" y="6485133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709338" y="189186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212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7</Words>
  <Application>Microsoft Office PowerPoint</Application>
  <PresentationFormat>Custom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yavooLab</dc:creator>
  <cp:lastModifiedBy>AyyavooLab</cp:lastModifiedBy>
  <cp:revision>1</cp:revision>
  <dcterms:created xsi:type="dcterms:W3CDTF">2015-09-07T18:06:31Z</dcterms:created>
  <dcterms:modified xsi:type="dcterms:W3CDTF">2015-09-07T18:08:46Z</dcterms:modified>
</cp:coreProperties>
</file>